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1E8775-E63E-45D0-8E89-29455496FB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D1893D-264C-4F28-8519-E4FEDFC0C5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0916F2-8E5E-410F-A038-80B0E8DDA0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AA49F-831B-43F7-949A-6FAC99DD7D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FBE890-EF7B-460D-A876-C388B86B18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1098DC-FFDD-413B-B5EF-3DAF362FE2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12E899-7ACC-4B54-8EF2-54DB648837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E2CEF-DF7A-4305-AE2E-51480D3747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4F00E-A16B-4B5A-AB1A-E376C60543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5D0F0-7A3E-479E-9549-FA8BCF92C6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E5F8E-BB90-4D2D-9A14-C142E20E4D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8AB38-4126-4A68-A370-B2D0EA67C1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EDF694-F88F-45E8-A8A6-A97CCE6E0201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22919" t="20072" r="22919" b="3687"/>
          <a:stretch/>
        </p:blipFill>
        <p:spPr>
          <a:xfrm>
            <a:off x="2111400" y="380880"/>
            <a:ext cx="5203800" cy="60962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0440" y="88920"/>
            <a:ext cx="1469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arbamyl phosphate synthetase I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2362320" y="200160"/>
            <a:ext cx="1447560" cy="533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591000" y="714240"/>
            <a:ext cx="990360" cy="228600"/>
          </a:xfrm>
          <a:prstGeom prst="ellipse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7855920" y="860400"/>
            <a:ext cx="12016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conitase 2, mitochondrial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 flipH="1">
            <a:off x="6324120" y="990720"/>
            <a:ext cx="762120" cy="45720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 flipH="1">
            <a:off x="1442880" y="200160"/>
            <a:ext cx="9144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7884000" y="114480"/>
            <a:ext cx="1186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sarcosine dehydrogen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7086600" y="990720"/>
            <a:ext cx="83808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 flipH="1">
            <a:off x="5257800" y="228600"/>
            <a:ext cx="1828800" cy="106668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7086600" y="228600"/>
            <a:ext cx="83808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3747960" y="3273480"/>
            <a:ext cx="9144000" cy="360"/>
          </a:xfrm>
          <a:prstGeom prst="rect">
            <a:avLst/>
          </a:prstGeom>
          <a:solidFill>
            <a:srgbClr val="cce4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7760880" y="6049800"/>
            <a:ext cx="1299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Cu/Zn superoxide dismut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 flipH="1" flipV="1">
            <a:off x="5097240" y="5967000"/>
            <a:ext cx="160200" cy="20484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3600" y="1036800"/>
            <a:ext cx="1226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  <a:ea typeface="Arial"/>
              </a:rPr>
              <a:t>heat shock 70kD protein 5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3960" y="639720"/>
            <a:ext cx="756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a</a:t>
            </a: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ldh1l1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11880" y="258840"/>
            <a:ext cx="488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album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457200" y="371520"/>
            <a:ext cx="198108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3352680" y="1523880"/>
            <a:ext cx="1219320" cy="228600"/>
          </a:xfrm>
          <a:prstGeom prst="ellipse">
            <a:avLst/>
          </a:prstGeom>
          <a:noFill/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2438280" y="380880"/>
            <a:ext cx="1371600" cy="114300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2298600" y="569880"/>
            <a:ext cx="914400" cy="70488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1142640" y="571680"/>
            <a:ext cx="11430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5760" y="457200"/>
            <a:ext cx="1172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valosin containing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762120" y="762120"/>
            <a:ext cx="152388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2286000" y="762120"/>
            <a:ext cx="533520" cy="53316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-5400" y="851040"/>
            <a:ext cx="459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dufs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17600" y="947880"/>
            <a:ext cx="19047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2322360" y="950760"/>
            <a:ext cx="412920" cy="497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2743200" y="1447920"/>
            <a:ext cx="457200" cy="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-6480" y="1447920"/>
            <a:ext cx="485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  <a:ea typeface="Arial"/>
              </a:rPr>
              <a:t>HSP60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2125800" y="1568520"/>
            <a:ext cx="1523880" cy="45720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7696440" y="2097000"/>
            <a:ext cx="1374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-hydroxyphytanoyl-CoA ly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8304480" y="289080"/>
            <a:ext cx="767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41129 radix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7495200" y="457200"/>
            <a:ext cx="1575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Propionyl-Coenzyme A carboxyl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 flipH="1">
            <a:off x="7162560" y="380880"/>
            <a:ext cx="11430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 flipH="1">
            <a:off x="5562360" y="380880"/>
            <a:ext cx="1600200" cy="106704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 flipH="1">
            <a:off x="7162920" y="533520"/>
            <a:ext cx="38088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 flipH="1">
            <a:off x="5562360" y="533520"/>
            <a:ext cx="1600200" cy="106668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 flipH="1">
            <a:off x="5257440" y="1600200"/>
            <a:ext cx="304920" cy="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6019920" y="1981080"/>
            <a:ext cx="990360" cy="228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7010280" y="2209680"/>
            <a:ext cx="6858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8385120" y="657360"/>
            <a:ext cx="663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dha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 flipH="1">
            <a:off x="5638680" y="762120"/>
            <a:ext cx="1371600" cy="99036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6997680" y="762120"/>
            <a:ext cx="1447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4343400" y="1868400"/>
            <a:ext cx="838080" cy="76320"/>
          </a:xfrm>
          <a:prstGeom prst="ellipse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5181480" y="1905120"/>
            <a:ext cx="838440" cy="75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7413480" y="1066680"/>
            <a:ext cx="1656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ystathionine beta-synthase isoform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7619400" y="1258920"/>
            <a:ext cx="14547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stress-induced phosphoprotein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7599960" y="1625760"/>
            <a:ext cx="1460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butyryl </a:t>
            </a: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c</a:t>
            </a: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oenzyme </a:t>
            </a: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a</a:t>
            </a: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 synthetase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7614720" y="1441440"/>
            <a:ext cx="1442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-ketoacyl-Coenzyme A thiol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8362800" y="1774800"/>
            <a:ext cx="712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ransketol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7102440" y="1214280"/>
            <a:ext cx="304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 flipH="1">
            <a:off x="5562360" y="1219320"/>
            <a:ext cx="1523880" cy="60948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7086600" y="1371600"/>
            <a:ext cx="60948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 flipH="1">
            <a:off x="5638680" y="1371600"/>
            <a:ext cx="1447920" cy="45720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7162920" y="1752480"/>
            <a:ext cx="4572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7091280" y="1523880"/>
            <a:ext cx="533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 flipH="1" flipV="1">
            <a:off x="6476760" y="1828800"/>
            <a:ext cx="685800" cy="7632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8265960" y="1936800"/>
            <a:ext cx="785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a</a:t>
            </a: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ldh4a1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 flipH="1" flipV="1">
            <a:off x="6400800" y="1981080"/>
            <a:ext cx="533520" cy="7632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6934320" y="2057400"/>
            <a:ext cx="13716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7162920" y="1905120"/>
            <a:ext cx="12189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 flipH="1">
            <a:off x="5866920" y="1752480"/>
            <a:ext cx="1295640" cy="7632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 flipH="1">
            <a:off x="6629400" y="1523880"/>
            <a:ext cx="457200" cy="15264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8294760" y="5281560"/>
            <a:ext cx="781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peroxiredoxin 6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 flipH="1" flipV="1">
            <a:off x="5334120" y="4314600"/>
            <a:ext cx="457200" cy="106668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8366040" y="4038480"/>
            <a:ext cx="668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aao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 flipH="1" flipV="1">
            <a:off x="5409720" y="3689280"/>
            <a:ext cx="381240" cy="45720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8408520" y="5075280"/>
            <a:ext cx="654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Nit protein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 flipH="1" flipV="1">
            <a:off x="5409720" y="3886200"/>
            <a:ext cx="1143000" cy="129528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8045640" y="4221000"/>
            <a:ext cx="1020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carbonic anhydrase 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 flipV="1">
            <a:off x="6324480" y="4190760"/>
            <a:ext cx="0" cy="15228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7687440" y="4618080"/>
            <a:ext cx="1406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  <a:ea typeface="Arial"/>
              </a:rPr>
              <a:t>glutathione S-transferase mu 1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7595280" y="4419720"/>
            <a:ext cx="1499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lutathione S-transferase </a:t>
            </a:r>
            <a:r>
              <a:rPr b="0" lang="de-DE" sz="700" spc="-1" strike="noStrike">
                <a:solidFill>
                  <a:srgbClr val="000000"/>
                </a:solidFill>
                <a:latin typeface="Arial"/>
                <a:ea typeface="Arial"/>
              </a:rPr>
              <a:t>alpha 3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7936200" y="5670720"/>
            <a:ext cx="1137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lutathione peroxidase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 flipH="1" flipV="1">
            <a:off x="5029200" y="4724280"/>
            <a:ext cx="533520" cy="106704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 flipV="1">
            <a:off x="6461280" y="4411440"/>
            <a:ext cx="0" cy="15228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8294760" y="4838760"/>
            <a:ext cx="781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eroxiredoxin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7820640" y="2286000"/>
            <a:ext cx="1239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ldehyde dehydrogenase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mitochondrial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5029200" y="2209680"/>
            <a:ext cx="685800" cy="152640"/>
          </a:xfrm>
          <a:prstGeom prst="ellipse">
            <a:avLst/>
          </a:prstGeom>
          <a:noFill/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8571960" y="2538360"/>
            <a:ext cx="488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enol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4892760" y="2362320"/>
            <a:ext cx="838080" cy="152280"/>
          </a:xfrm>
          <a:prstGeom prst="ellipse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6183360" y="2638440"/>
            <a:ext cx="2438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7911000" y="2682720"/>
            <a:ext cx="1157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branched chain ketoacid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dehydrogenase E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 flipH="1" flipV="1">
            <a:off x="5486400" y="2590560"/>
            <a:ext cx="380880" cy="22860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8261640" y="3154320"/>
            <a:ext cx="801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rginase 1, liver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7909560" y="2971800"/>
            <a:ext cx="11667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sorbitol dehydrogenase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 flipH="1" flipV="1">
            <a:off x="5486040" y="2895120"/>
            <a:ext cx="1143000" cy="38124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 flipH="1" flipV="1">
            <a:off x="5807160" y="2927160"/>
            <a:ext cx="457200" cy="15228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8110080" y="3306600"/>
            <a:ext cx="951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ldose 1-epimer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 flipH="1" flipV="1">
            <a:off x="5614920" y="3107880"/>
            <a:ext cx="990720" cy="30492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7864560" y="3452760"/>
            <a:ext cx="132084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  <a:ea typeface="Arial"/>
              </a:rPr>
              <a:t>fructose bisphosphatase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7936920" y="3863880"/>
            <a:ext cx="1146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malate dehydrogenase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 flipH="1" flipV="1">
            <a:off x="5076360" y="3360600"/>
            <a:ext cx="1019160" cy="60192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 flipH="1" flipV="1">
            <a:off x="5105160" y="3047760"/>
            <a:ext cx="1066680" cy="53316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5562720" y="5791320"/>
            <a:ext cx="23619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5791320" y="5394240"/>
            <a:ext cx="2514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6553080" y="5181480"/>
            <a:ext cx="18288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 flipH="1" flipV="1">
            <a:off x="6477120" y="4800240"/>
            <a:ext cx="304560" cy="15228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6324480" y="4343400"/>
            <a:ext cx="175284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5943600" y="2441520"/>
            <a:ext cx="190512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 flipH="1" flipV="1">
            <a:off x="5714640" y="2285640"/>
            <a:ext cx="228600" cy="15228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 flipH="1" flipV="1">
            <a:off x="5715000" y="2406240"/>
            <a:ext cx="457200" cy="228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 flipH="1">
            <a:off x="5866920" y="2819520"/>
            <a:ext cx="20574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6248520" y="3079800"/>
            <a:ext cx="16761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6629400" y="3276720"/>
            <a:ext cx="167652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6605640" y="3413160"/>
            <a:ext cx="1523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7408080" y="3641760"/>
            <a:ext cx="16606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quinolinate phosphoribosyltransfer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 flipH="1" flipV="1">
            <a:off x="5334120" y="3200400"/>
            <a:ext cx="806400" cy="54936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6140520" y="3762360"/>
            <a:ext cx="1295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6172200" y="3581280"/>
            <a:ext cx="175248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6095880" y="3962520"/>
            <a:ext cx="18288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5791320" y="4138560"/>
            <a:ext cx="25905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 flipH="1">
            <a:off x="6629400" y="4519440"/>
            <a:ext cx="990720" cy="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6477120" y="4572000"/>
            <a:ext cx="228600" cy="15228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6705720" y="4724280"/>
            <a:ext cx="9144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6781680" y="4952880"/>
            <a:ext cx="15242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7425000" y="5486400"/>
            <a:ext cx="1639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3-mercaptopyruvate sulfurtransfer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 flipV="1">
            <a:off x="5181480" y="3681360"/>
            <a:ext cx="0" cy="91440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5181480" y="4595760"/>
            <a:ext cx="457200" cy="99072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5638680" y="5586480"/>
            <a:ext cx="18288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 flipH="1" flipV="1">
            <a:off x="4771800" y="4419360"/>
            <a:ext cx="28440" cy="53316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4800600" y="4952880"/>
            <a:ext cx="609480" cy="103032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>
            <a:off x="8289720" y="5867280"/>
            <a:ext cx="781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peroxiredoxin 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 flipH="1">
            <a:off x="5410080" y="5987880"/>
            <a:ext cx="289584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5257800" y="6172200"/>
            <a:ext cx="2514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3032280" y="3268800"/>
            <a:ext cx="9144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7451640" y="6248520"/>
            <a:ext cx="175284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  <a:ea typeface="Arial"/>
              </a:rPr>
              <a:t>indolethylamine N-methyltransferase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 flipV="1">
            <a:off x="4732200" y="4122360"/>
            <a:ext cx="0" cy="224172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4740120" y="6372360"/>
            <a:ext cx="27432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2666880" y="1523880"/>
            <a:ext cx="457200" cy="152640"/>
          </a:xfrm>
          <a:prstGeom prst="ellipse">
            <a:avLst/>
          </a:prstGeom>
          <a:noFill/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1219320" y="1143000"/>
            <a:ext cx="99036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2209680" y="1143000"/>
            <a:ext cx="457200" cy="45720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-5760" y="1616040"/>
            <a:ext cx="16606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ormiminotransferase cyclodeamin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>
            <a:off x="-3600" y="1768320"/>
            <a:ext cx="84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Selenbp1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9720" y="1219320"/>
            <a:ext cx="1518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lucose regulated protein, 58 kDa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>
            <a:off x="1447920" y="1339920"/>
            <a:ext cx="7617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2514600" y="1600200"/>
            <a:ext cx="1608120" cy="404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>
            <a:off x="4114800" y="1981080"/>
            <a:ext cx="533520" cy="76320"/>
          </a:xfrm>
          <a:prstGeom prst="ellipse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2209680" y="1339920"/>
            <a:ext cx="304920" cy="260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>
            <a:off x="441360" y="1555920"/>
            <a:ext cx="167652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>
            <a:off x="838080" y="1905120"/>
            <a:ext cx="13716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>
            <a:off x="1600200" y="1752480"/>
            <a:ext cx="6094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"/>
          <p:cNvSpPr/>
          <p:nvPr/>
        </p:nvSpPr>
        <p:spPr>
          <a:xfrm>
            <a:off x="2209680" y="1752480"/>
            <a:ext cx="1447920" cy="381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>
            <a:off x="3657600" y="2133720"/>
            <a:ext cx="762120" cy="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"/>
          <p:cNvSpPr/>
          <p:nvPr/>
        </p:nvSpPr>
        <p:spPr>
          <a:xfrm>
            <a:off x="2209680" y="1905120"/>
            <a:ext cx="1447920" cy="30456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"/>
          <p:cNvSpPr/>
          <p:nvPr/>
        </p:nvSpPr>
        <p:spPr>
          <a:xfrm>
            <a:off x="3657600" y="2209680"/>
            <a:ext cx="1066680" cy="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>
            <a:off x="2880" y="1965240"/>
            <a:ext cx="400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atp5b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"/>
          <p:cNvSpPr/>
          <p:nvPr/>
        </p:nvSpPr>
        <p:spPr>
          <a:xfrm>
            <a:off x="380880" y="2057400"/>
            <a:ext cx="19051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"/>
          <p:cNvSpPr/>
          <p:nvPr/>
        </p:nvSpPr>
        <p:spPr>
          <a:xfrm>
            <a:off x="2286000" y="2057400"/>
            <a:ext cx="457200" cy="228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>
            <a:off x="2695680" y="2262240"/>
            <a:ext cx="380880" cy="152280"/>
          </a:xfrm>
          <a:prstGeom prst="ellipse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"/>
          <p:cNvSpPr/>
          <p:nvPr/>
        </p:nvSpPr>
        <p:spPr>
          <a:xfrm>
            <a:off x="360" y="2925720"/>
            <a:ext cx="1220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ornithine aminotransfer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"/>
          <p:cNvSpPr/>
          <p:nvPr/>
        </p:nvSpPr>
        <p:spPr>
          <a:xfrm flipV="1">
            <a:off x="3581280" y="2542680"/>
            <a:ext cx="1051200" cy="50508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>
            <a:off x="3960" y="2362320"/>
            <a:ext cx="865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adenosine kin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"/>
          <p:cNvSpPr/>
          <p:nvPr/>
        </p:nvSpPr>
        <p:spPr>
          <a:xfrm>
            <a:off x="2880" y="2544840"/>
            <a:ext cx="3466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actg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"/>
          <p:cNvSpPr/>
          <p:nvPr/>
        </p:nvSpPr>
        <p:spPr>
          <a:xfrm>
            <a:off x="304920" y="2666880"/>
            <a:ext cx="2971800" cy="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>
            <a:off x="13680" y="2163600"/>
            <a:ext cx="2055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  <a:ea typeface="Arial"/>
              </a:rPr>
              <a:t>ubiquinol-cytochrome c reductase core protein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"/>
          <p:cNvSpPr/>
          <p:nvPr/>
        </p:nvSpPr>
        <p:spPr>
          <a:xfrm>
            <a:off x="2057400" y="2286000"/>
            <a:ext cx="2286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"/>
          <p:cNvSpPr/>
          <p:nvPr/>
        </p:nvSpPr>
        <p:spPr>
          <a:xfrm>
            <a:off x="2286000" y="2286000"/>
            <a:ext cx="380880" cy="15228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>
            <a:off x="2666880" y="2438280"/>
            <a:ext cx="990720" cy="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"/>
          <p:cNvSpPr/>
          <p:nvPr/>
        </p:nvSpPr>
        <p:spPr>
          <a:xfrm>
            <a:off x="2286000" y="2538360"/>
            <a:ext cx="2133720" cy="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"/>
          <p:cNvSpPr/>
          <p:nvPr/>
        </p:nvSpPr>
        <p:spPr>
          <a:xfrm flipV="1">
            <a:off x="2286000" y="2462040"/>
            <a:ext cx="0" cy="763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 flipH="1">
            <a:off x="838080" y="2462040"/>
            <a:ext cx="1447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>
            <a:off x="1219320" y="3048120"/>
            <a:ext cx="236196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-3600" y="2743200"/>
            <a:ext cx="727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uclg2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685800" y="2835360"/>
            <a:ext cx="2819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/>
          <p:cNvSpPr/>
          <p:nvPr/>
        </p:nvSpPr>
        <p:spPr>
          <a:xfrm flipV="1">
            <a:off x="3513240" y="2682720"/>
            <a:ext cx="380880" cy="15264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"/>
          <p:cNvSpPr/>
          <p:nvPr/>
        </p:nvSpPr>
        <p:spPr>
          <a:xfrm>
            <a:off x="2880" y="3352680"/>
            <a:ext cx="581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regucalc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"/>
          <p:cNvSpPr/>
          <p:nvPr/>
        </p:nvSpPr>
        <p:spPr>
          <a:xfrm>
            <a:off x="9000" y="3124080"/>
            <a:ext cx="1866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dimethylarginine dimethylaminohydrolase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"/>
          <p:cNvSpPr/>
          <p:nvPr/>
        </p:nvSpPr>
        <p:spPr>
          <a:xfrm>
            <a:off x="1828800" y="3224160"/>
            <a:ext cx="18288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"/>
          <p:cNvSpPr/>
          <p:nvPr/>
        </p:nvSpPr>
        <p:spPr>
          <a:xfrm flipV="1">
            <a:off x="3657600" y="3124080"/>
            <a:ext cx="457200" cy="9216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"/>
          <p:cNvSpPr/>
          <p:nvPr/>
        </p:nvSpPr>
        <p:spPr>
          <a:xfrm>
            <a:off x="533520" y="3429000"/>
            <a:ext cx="190476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"/>
          <p:cNvSpPr/>
          <p:nvPr/>
        </p:nvSpPr>
        <p:spPr>
          <a:xfrm>
            <a:off x="2819520" y="3276720"/>
            <a:ext cx="761760" cy="152280"/>
          </a:xfrm>
          <a:prstGeom prst="ellipse">
            <a:avLst/>
          </a:prstGeom>
          <a:noFill/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"/>
          <p:cNvSpPr/>
          <p:nvPr/>
        </p:nvSpPr>
        <p:spPr>
          <a:xfrm flipV="1">
            <a:off x="2438280" y="3352680"/>
            <a:ext cx="381240" cy="7632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"/>
          <p:cNvSpPr/>
          <p:nvPr/>
        </p:nvSpPr>
        <p:spPr>
          <a:xfrm>
            <a:off x="7920" y="3544920"/>
            <a:ext cx="120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ructose bisphosphatase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"/>
          <p:cNvSpPr/>
          <p:nvPr/>
        </p:nvSpPr>
        <p:spPr>
          <a:xfrm>
            <a:off x="1143000" y="3657600"/>
            <a:ext cx="17524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"/>
          <p:cNvSpPr/>
          <p:nvPr/>
        </p:nvSpPr>
        <p:spPr>
          <a:xfrm flipV="1">
            <a:off x="2895480" y="3047760"/>
            <a:ext cx="1676520" cy="60948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"/>
          <p:cNvSpPr/>
          <p:nvPr/>
        </p:nvSpPr>
        <p:spPr>
          <a:xfrm>
            <a:off x="4680" y="4092480"/>
            <a:ext cx="668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d</a:t>
            </a: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hdh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"/>
          <p:cNvSpPr/>
          <p:nvPr/>
        </p:nvSpPr>
        <p:spPr>
          <a:xfrm flipV="1">
            <a:off x="2590920" y="3292560"/>
            <a:ext cx="2125440" cy="89856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"/>
          <p:cNvSpPr/>
          <p:nvPr/>
        </p:nvSpPr>
        <p:spPr>
          <a:xfrm>
            <a:off x="3960" y="3894120"/>
            <a:ext cx="816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polipoprotein 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"/>
          <p:cNvSpPr/>
          <p:nvPr/>
        </p:nvSpPr>
        <p:spPr>
          <a:xfrm>
            <a:off x="838080" y="4002120"/>
            <a:ext cx="19051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"/>
          <p:cNvSpPr/>
          <p:nvPr/>
        </p:nvSpPr>
        <p:spPr>
          <a:xfrm flipV="1">
            <a:off x="2743200" y="3565440"/>
            <a:ext cx="982800" cy="44136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"/>
          <p:cNvSpPr/>
          <p:nvPr/>
        </p:nvSpPr>
        <p:spPr>
          <a:xfrm>
            <a:off x="7920" y="4923000"/>
            <a:ext cx="1044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type II peroxiredoxin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"/>
          <p:cNvSpPr/>
          <p:nvPr/>
        </p:nvSpPr>
        <p:spPr>
          <a:xfrm flipV="1">
            <a:off x="2209680" y="4800240"/>
            <a:ext cx="914400" cy="22860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5" name=""/>
          <p:cNvSpPr/>
          <p:nvPr/>
        </p:nvSpPr>
        <p:spPr>
          <a:xfrm>
            <a:off x="0" y="5141880"/>
            <a:ext cx="736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TP synth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"/>
          <p:cNvSpPr/>
          <p:nvPr/>
        </p:nvSpPr>
        <p:spPr>
          <a:xfrm flipV="1">
            <a:off x="2590920" y="4647960"/>
            <a:ext cx="1218960" cy="60948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7" name=""/>
          <p:cNvSpPr/>
          <p:nvPr/>
        </p:nvSpPr>
        <p:spPr>
          <a:xfrm>
            <a:off x="5040" y="4724280"/>
            <a:ext cx="869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apolipoprotein A-I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8" name=""/>
          <p:cNvSpPr/>
          <p:nvPr/>
        </p:nvSpPr>
        <p:spPr>
          <a:xfrm flipV="1">
            <a:off x="2270160" y="4451400"/>
            <a:ext cx="1066680" cy="38088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9" name=""/>
          <p:cNvSpPr/>
          <p:nvPr/>
        </p:nvSpPr>
        <p:spPr>
          <a:xfrm>
            <a:off x="7560" y="3724200"/>
            <a:ext cx="1495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MAWD binding protein homolog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0" name=""/>
          <p:cNvSpPr/>
          <p:nvPr/>
        </p:nvSpPr>
        <p:spPr>
          <a:xfrm flipV="1">
            <a:off x="2362320" y="3657240"/>
            <a:ext cx="761760" cy="15228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1" name=""/>
          <p:cNvSpPr/>
          <p:nvPr/>
        </p:nvSpPr>
        <p:spPr>
          <a:xfrm flipV="1">
            <a:off x="3962520" y="3657600"/>
            <a:ext cx="380880" cy="129528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2" name=""/>
          <p:cNvSpPr/>
          <p:nvPr/>
        </p:nvSpPr>
        <p:spPr>
          <a:xfrm>
            <a:off x="-3960" y="5622840"/>
            <a:ext cx="79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ketohexokin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3" name=""/>
          <p:cNvSpPr/>
          <p:nvPr/>
        </p:nvSpPr>
        <p:spPr>
          <a:xfrm flipH="1">
            <a:off x="1447920" y="3809880"/>
            <a:ext cx="9144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4" name=""/>
          <p:cNvSpPr/>
          <p:nvPr/>
        </p:nvSpPr>
        <p:spPr>
          <a:xfrm>
            <a:off x="2520" y="4297320"/>
            <a:ext cx="5374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prohibit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5" name=""/>
          <p:cNvSpPr/>
          <p:nvPr/>
        </p:nvSpPr>
        <p:spPr>
          <a:xfrm>
            <a:off x="525600" y="4422600"/>
            <a:ext cx="18288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6" name=""/>
          <p:cNvSpPr/>
          <p:nvPr/>
        </p:nvSpPr>
        <p:spPr>
          <a:xfrm flipV="1">
            <a:off x="2362320" y="3886200"/>
            <a:ext cx="1447560" cy="53352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7" name=""/>
          <p:cNvSpPr/>
          <p:nvPr/>
        </p:nvSpPr>
        <p:spPr>
          <a:xfrm>
            <a:off x="990720" y="5029200"/>
            <a:ext cx="121896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8" name=""/>
          <p:cNvSpPr/>
          <p:nvPr/>
        </p:nvSpPr>
        <p:spPr>
          <a:xfrm>
            <a:off x="10080" y="4516560"/>
            <a:ext cx="1572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guanidinoacetate methyltransfer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9" name=""/>
          <p:cNvSpPr/>
          <p:nvPr/>
        </p:nvSpPr>
        <p:spPr>
          <a:xfrm>
            <a:off x="9000" y="5334120"/>
            <a:ext cx="106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proteasome (prosome,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 </a:t>
            </a: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macropain) 28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0" name=""/>
          <p:cNvSpPr/>
          <p:nvPr/>
        </p:nvSpPr>
        <p:spPr>
          <a:xfrm flipV="1">
            <a:off x="2362320" y="4114800"/>
            <a:ext cx="1218960" cy="53352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1" name=""/>
          <p:cNvSpPr/>
          <p:nvPr/>
        </p:nvSpPr>
        <p:spPr>
          <a:xfrm>
            <a:off x="1600200" y="4648320"/>
            <a:ext cx="76212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2" name=""/>
          <p:cNvSpPr/>
          <p:nvPr/>
        </p:nvSpPr>
        <p:spPr>
          <a:xfrm flipV="1">
            <a:off x="3886200" y="3962520"/>
            <a:ext cx="304920" cy="83808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3" name=""/>
          <p:cNvSpPr/>
          <p:nvPr/>
        </p:nvSpPr>
        <p:spPr>
          <a:xfrm>
            <a:off x="685800" y="4191120"/>
            <a:ext cx="190512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4" name=""/>
          <p:cNvSpPr/>
          <p:nvPr/>
        </p:nvSpPr>
        <p:spPr>
          <a:xfrm>
            <a:off x="838080" y="4832280"/>
            <a:ext cx="1447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5" name=""/>
          <p:cNvSpPr/>
          <p:nvPr/>
        </p:nvSpPr>
        <p:spPr>
          <a:xfrm>
            <a:off x="685800" y="5257800"/>
            <a:ext cx="19051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6" name=""/>
          <p:cNvSpPr/>
          <p:nvPr/>
        </p:nvSpPr>
        <p:spPr>
          <a:xfrm>
            <a:off x="9000" y="6218280"/>
            <a:ext cx="1567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phosphatidylcholine transfer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7" name=""/>
          <p:cNvSpPr/>
          <p:nvPr/>
        </p:nvSpPr>
        <p:spPr>
          <a:xfrm>
            <a:off x="1066680" y="5486400"/>
            <a:ext cx="121932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8" name=""/>
          <p:cNvSpPr/>
          <p:nvPr/>
        </p:nvSpPr>
        <p:spPr>
          <a:xfrm flipV="1">
            <a:off x="2286000" y="4800240"/>
            <a:ext cx="1600200" cy="68580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"/>
          <p:cNvSpPr/>
          <p:nvPr/>
        </p:nvSpPr>
        <p:spPr>
          <a:xfrm flipH="1">
            <a:off x="2361960" y="4952880"/>
            <a:ext cx="1600200" cy="762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0" name=""/>
          <p:cNvSpPr/>
          <p:nvPr/>
        </p:nvSpPr>
        <p:spPr>
          <a:xfrm>
            <a:off x="838080" y="5715000"/>
            <a:ext cx="15242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1" name=""/>
          <p:cNvSpPr/>
          <p:nvPr/>
        </p:nvSpPr>
        <p:spPr>
          <a:xfrm>
            <a:off x="4680" y="5821200"/>
            <a:ext cx="781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peroxiredoxin 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2" name=""/>
          <p:cNvSpPr/>
          <p:nvPr/>
        </p:nvSpPr>
        <p:spPr>
          <a:xfrm>
            <a:off x="762120" y="5927760"/>
            <a:ext cx="16002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3" name=""/>
          <p:cNvSpPr/>
          <p:nvPr/>
        </p:nvSpPr>
        <p:spPr>
          <a:xfrm flipV="1">
            <a:off x="2362320" y="4952880"/>
            <a:ext cx="1828800" cy="99072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4" name=""/>
          <p:cNvSpPr/>
          <p:nvPr/>
        </p:nvSpPr>
        <p:spPr>
          <a:xfrm>
            <a:off x="-2880" y="6019920"/>
            <a:ext cx="6836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DJ-1,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5" name=""/>
          <p:cNvSpPr/>
          <p:nvPr/>
        </p:nvSpPr>
        <p:spPr>
          <a:xfrm flipV="1">
            <a:off x="4191120" y="4419360"/>
            <a:ext cx="152280" cy="53316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6" name=""/>
          <p:cNvSpPr/>
          <p:nvPr/>
        </p:nvSpPr>
        <p:spPr>
          <a:xfrm>
            <a:off x="685800" y="6095880"/>
            <a:ext cx="18288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7" name=""/>
          <p:cNvSpPr/>
          <p:nvPr/>
        </p:nvSpPr>
        <p:spPr>
          <a:xfrm flipV="1">
            <a:off x="2514600" y="5105160"/>
            <a:ext cx="1676520" cy="990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8" name=""/>
          <p:cNvSpPr/>
          <p:nvPr/>
        </p:nvSpPr>
        <p:spPr>
          <a:xfrm flipV="1">
            <a:off x="4191120" y="4648320"/>
            <a:ext cx="152280" cy="457200"/>
          </a:xfrm>
          <a:prstGeom prst="line">
            <a:avLst/>
          </a:prstGeom>
          <a:ln w="324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9" name=""/>
          <p:cNvSpPr/>
          <p:nvPr/>
        </p:nvSpPr>
        <p:spPr>
          <a:xfrm flipV="1">
            <a:off x="4191120" y="4419720"/>
            <a:ext cx="252360" cy="914400"/>
          </a:xfrm>
          <a:prstGeom prst="line">
            <a:avLst/>
          </a:prstGeom>
          <a:ln w="324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0" name=""/>
          <p:cNvSpPr/>
          <p:nvPr/>
        </p:nvSpPr>
        <p:spPr>
          <a:xfrm flipH="1">
            <a:off x="2514240" y="5334120"/>
            <a:ext cx="1676520" cy="99036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1" name=""/>
          <p:cNvSpPr/>
          <p:nvPr/>
        </p:nvSpPr>
        <p:spPr>
          <a:xfrm>
            <a:off x="1600200" y="6324480"/>
            <a:ext cx="914400" cy="0"/>
          </a:xfrm>
          <a:prstGeom prst="line">
            <a:avLst/>
          </a:prstGeom>
          <a:ln w="324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06T09:17:38Z</dcterms:created>
  <dc:creator>msritort</dc:creator>
  <dc:description/>
  <dc:language>en-US</dc:language>
  <cp:lastModifiedBy>fschoppm</cp:lastModifiedBy>
  <dcterms:modified xsi:type="dcterms:W3CDTF">2009-09-02T18:01:39Z</dcterms:modified>
  <cp:revision>57</cp:revision>
  <dc:subject/>
  <dc:title>PowerPoint Presentation</dc:title>
</cp:coreProperties>
</file>